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02" r:id="rId2"/>
    <p:sldId id="297" r:id="rId3"/>
    <p:sldId id="304" r:id="rId4"/>
    <p:sldId id="305" r:id="rId5"/>
    <p:sldId id="303" r:id="rId6"/>
    <p:sldId id="306" r:id="rId7"/>
    <p:sldId id="299" r:id="rId8"/>
    <p:sldId id="298" r:id="rId9"/>
    <p:sldId id="288" r:id="rId10"/>
    <p:sldId id="277" r:id="rId11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eksma, A.C." initials="LA" lastIdx="10" clrIdx="0">
    <p:extLst>
      <p:ext uri="{19B8F6BF-5375-455C-9EA6-DF929625EA0E}">
        <p15:presenceInfo xmlns:p15="http://schemas.microsoft.com/office/powerpoint/2012/main" userId="S-1-5-21-2169066342-2480738168-2466311071-9651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26" autoAdjust="0"/>
    <p:restoredTop sz="94631"/>
  </p:normalViewPr>
  <p:slideViewPr>
    <p:cSldViewPr snapToGrid="0">
      <p:cViewPr>
        <p:scale>
          <a:sx n="90" d="100"/>
          <a:sy n="90" d="100"/>
        </p:scale>
        <p:origin x="1560" y="-153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114764-1CA6-4F20-991D-236D693EDA9E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078FC-A4AC-4BE8-838F-0AFD171D9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6316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 om de ondertitel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11048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1547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79356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20551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08520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73490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85403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11573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96366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28213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00657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AACEB5-A3C6-44DC-B203-D1AD4B96C787}" type="datetimeFigureOut">
              <a:rPr lang="nl-NL" smtClean="0"/>
              <a:t>23-12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019186-1045-4D5F-87C3-16179962909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68135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13.png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11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806" y="12432"/>
            <a:ext cx="6681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 sequences for quantitative real-time polymerase chain reaction (qPCR). Presented are the primer sequences of wild type (WT) and alternative transcripts (ALT) used for qPCR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2187014"/>
              </p:ext>
            </p:extLst>
          </p:nvPr>
        </p:nvGraphicFramePr>
        <p:xfrm>
          <a:off x="156471" y="763272"/>
          <a:ext cx="4755500" cy="5441455"/>
        </p:xfrm>
        <a:graphic>
          <a:graphicData uri="http://schemas.openxmlformats.org/drawingml/2006/table">
            <a:tbl>
              <a:tblPr/>
              <a:tblGrid>
                <a:gridCol w="1748447">
                  <a:extLst>
                    <a:ext uri="{9D8B030D-6E8A-4147-A177-3AD203B41FA5}">
                      <a16:colId xmlns:a16="http://schemas.microsoft.com/office/drawing/2014/main" val="569659142"/>
                    </a:ext>
                  </a:extLst>
                </a:gridCol>
                <a:gridCol w="3007053">
                  <a:extLst>
                    <a:ext uri="{9D8B030D-6E8A-4147-A177-3AD203B41FA5}">
                      <a16:colId xmlns:a16="http://schemas.microsoft.com/office/drawing/2014/main" val="133454421"/>
                    </a:ext>
                  </a:extLst>
                </a:gridCol>
              </a:tblGrid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M_ALT_F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CCAGAACTTT CAAGAAC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333413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M_AL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TTGTTCTGTATAAGAAAGGCAAAA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5700079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M_WT_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AGCTATTTGGTTTGAGAAG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155116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M-W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CCTGTTCAAAAGCAACA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4617759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1_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TCACTGCACACCTCTCAATG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853995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1_AL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GGTACCATTGGTGATGTAACAA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2002057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P1_WT_R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GGAAGCGGTAGTGTATAGAGG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8476738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KHD1_F_e2_e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AGAAGCAGCAGGAATTG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9796966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KHD1_F_e2_ae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AGCAGCAGCTTTTGCAGA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0782471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KHD1_R_e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GTCCACTTGTCCTGCAT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8522322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TTi1_WT_F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GAAGAGCACCACCACA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285453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TTi1_WT_R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CATCTGGACGGGTGTCA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614049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TTi1_ALT_F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CTTGAGAAGAGCACCACC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4880695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TTi1_ALT_R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AAAAGAGCACACTTCTTCAT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2040722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AP3K7_WT_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AATATGCTGAAGGGGG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0046401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AP3K7_W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TGCGTGGGCAGCAGTATA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7327029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AP3K7_ALT_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GCAGTTATCCCGTGTGA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9253382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AP3K7_AL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GCACTGCGAAAGAAAGG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5894752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RSF3_F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AACTGTCGAATGGTGA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3929507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RSF3_AL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GTGGTGAGAAGAGACATG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4043031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RSF3_WT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TTGGAGATCTGCGACGA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554142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_F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TCTTCTTTTGCGTCGC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5124736"/>
                  </a:ext>
                </a:extLst>
              </a:tr>
              <a:tr h="23658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nl-NL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_R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nl-NL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CCAAATCCGTTGACTCCG 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871" marR="55871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85653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655404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kstvak 23"/>
          <p:cNvSpPr txBox="1"/>
          <p:nvPr/>
        </p:nvSpPr>
        <p:spPr>
          <a:xfrm>
            <a:off x="1430392" y="707552"/>
            <a:ext cx="5538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>
                <a:latin typeface="Arial" panose="020B0604020202020204" pitchFamily="34" charset="0"/>
                <a:cs typeface="Arial" panose="020B0604020202020204" pitchFamily="34" charset="0"/>
              </a:rPr>
              <a:t>NALM-6 </a:t>
            </a:r>
            <a:r>
              <a:rPr lang="nl-NL" sz="1400" dirty="0" err="1">
                <a:latin typeface="Arial" panose="020B0604020202020204" pitchFamily="34" charset="0"/>
                <a:cs typeface="Arial" panose="020B0604020202020204" pitchFamily="34" charset="0"/>
              </a:rPr>
              <a:t>isogenic</a:t>
            </a:r>
            <a:r>
              <a:rPr lang="nl-NL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nl-NL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400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nl-NL" sz="1400" dirty="0">
                <a:latin typeface="Arial" panose="020B0604020202020204" pitchFamily="34" charset="0"/>
                <a:cs typeface="Arial" panose="020B0604020202020204" pitchFamily="34" charset="0"/>
              </a:rPr>
              <a:t> -/+ </a:t>
            </a:r>
            <a:r>
              <a:rPr lang="nl-NL" sz="14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nl-NL" sz="1400" dirty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29808" y="1016627"/>
            <a:ext cx="7122115" cy="3637545"/>
            <a:chOff x="-20707" y="748161"/>
            <a:chExt cx="7122115" cy="3637545"/>
          </a:xfrm>
        </p:grpSpPr>
        <p:sp>
          <p:nvSpPr>
            <p:cNvPr id="25" name="Tekstvak 24"/>
            <p:cNvSpPr txBox="1"/>
            <p:nvPr/>
          </p:nvSpPr>
          <p:spPr>
            <a:xfrm>
              <a:off x="3930697" y="3924041"/>
              <a:ext cx="30357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>
                <a:buFontTx/>
                <a:buChar char="-"/>
              </a:pPr>
              <a:r>
                <a:rPr lang="nl-NL" sz="12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  <a:p>
              <a:r>
                <a:rPr lang="nl-NL" sz="1200" dirty="0">
                  <a:latin typeface="Arial" panose="020B0604020202020204" pitchFamily="34" charset="0"/>
                  <a:cs typeface="Arial" panose="020B0604020202020204" pitchFamily="34" charset="0"/>
                </a:rPr>
                <a:t>+  </a:t>
              </a:r>
              <a:r>
                <a:rPr lang="nl-NL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DKi</a:t>
              </a:r>
              <a:r>
                <a:rPr lang="nl-NL" sz="1200" dirty="0">
                  <a:latin typeface="Arial" panose="020B0604020202020204" pitchFamily="34" charset="0"/>
                  <a:cs typeface="Arial" panose="020B0604020202020204" pitchFamily="34" charset="0"/>
                </a:rPr>
                <a:t> 0.5uM (</a:t>
              </a:r>
              <a:r>
                <a:rPr lang="nl-NL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lbociclib</a:t>
              </a:r>
              <a:r>
                <a:rPr lang="nl-NL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-20707" y="748161"/>
              <a:ext cx="7122115" cy="3164072"/>
              <a:chOff x="-20707" y="748161"/>
              <a:chExt cx="7122115" cy="3164072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612694" y="748161"/>
                <a:ext cx="6488714" cy="3164072"/>
                <a:chOff x="612694" y="748161"/>
                <a:chExt cx="6488714" cy="3164072"/>
              </a:xfrm>
            </p:grpSpPr>
            <p:cxnSp>
              <p:nvCxnSpPr>
                <p:cNvPr id="20" name="Rechte verbindingslijn 19"/>
                <p:cNvCxnSpPr/>
                <p:nvPr/>
              </p:nvCxnSpPr>
              <p:spPr>
                <a:xfrm>
                  <a:off x="620688" y="1126162"/>
                  <a:ext cx="254365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1" name="Groep 30"/>
                <p:cNvGrpSpPr/>
                <p:nvPr/>
              </p:nvGrpSpPr>
              <p:grpSpPr>
                <a:xfrm>
                  <a:off x="612694" y="748161"/>
                  <a:ext cx="6488714" cy="3164072"/>
                  <a:chOff x="462425" y="748161"/>
                  <a:chExt cx="6488714" cy="3164072"/>
                </a:xfrm>
              </p:grpSpPr>
              <p:sp>
                <p:nvSpPr>
                  <p:cNvPr id="16" name="Tekstvak 15"/>
                  <p:cNvSpPr txBox="1"/>
                  <p:nvPr/>
                </p:nvSpPr>
                <p:spPr>
                  <a:xfrm>
                    <a:off x="3963098" y="1228996"/>
                    <a:ext cx="79208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l-NL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700E</a:t>
                    </a:r>
                  </a:p>
                </p:txBody>
              </p:sp>
              <p:sp>
                <p:nvSpPr>
                  <p:cNvPr id="17" name="Tekstvak 16"/>
                  <p:cNvSpPr txBox="1"/>
                  <p:nvPr/>
                </p:nvSpPr>
                <p:spPr>
                  <a:xfrm>
                    <a:off x="4745210" y="1228995"/>
                    <a:ext cx="85879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nl-NL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666N</a:t>
                    </a:r>
                  </a:p>
                </p:txBody>
              </p:sp>
              <p:grpSp>
                <p:nvGrpSpPr>
                  <p:cNvPr id="30" name="Groep 29"/>
                  <p:cNvGrpSpPr/>
                  <p:nvPr/>
                </p:nvGrpSpPr>
                <p:grpSpPr>
                  <a:xfrm>
                    <a:off x="462425" y="748161"/>
                    <a:ext cx="6488714" cy="3164072"/>
                    <a:chOff x="462425" y="748161"/>
                    <a:chExt cx="6488714" cy="3164072"/>
                  </a:xfrm>
                </p:grpSpPr>
                <p:sp>
                  <p:nvSpPr>
                    <p:cNvPr id="12" name="Tekstvak 11"/>
                    <p:cNvSpPr txBox="1"/>
                    <p:nvPr/>
                  </p:nvSpPr>
                  <p:spPr>
                    <a:xfrm>
                      <a:off x="620688" y="1239887"/>
                      <a:ext cx="57606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nl-NL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</a:t>
                      </a:r>
                    </a:p>
                  </p:txBody>
                </p:sp>
                <p:sp>
                  <p:nvSpPr>
                    <p:cNvPr id="13" name="Tekstvak 12"/>
                    <p:cNvSpPr txBox="1"/>
                    <p:nvPr/>
                  </p:nvSpPr>
                  <p:spPr>
                    <a:xfrm>
                      <a:off x="1379422" y="1235936"/>
                      <a:ext cx="79208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nl-NL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700E</a:t>
                      </a:r>
                    </a:p>
                  </p:txBody>
                </p:sp>
                <p:sp>
                  <p:nvSpPr>
                    <p:cNvPr id="15" name="Tekstvak 14"/>
                    <p:cNvSpPr txBox="1"/>
                    <p:nvPr/>
                  </p:nvSpPr>
                  <p:spPr>
                    <a:xfrm>
                      <a:off x="3204364" y="1232947"/>
                      <a:ext cx="57606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nl-NL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</a:t>
                      </a:r>
                    </a:p>
                  </p:txBody>
                </p:sp>
                <p:grpSp>
                  <p:nvGrpSpPr>
                    <p:cNvPr id="29" name="Groep 28"/>
                    <p:cNvGrpSpPr/>
                    <p:nvPr/>
                  </p:nvGrpSpPr>
                  <p:grpSpPr>
                    <a:xfrm>
                      <a:off x="462425" y="748161"/>
                      <a:ext cx="6488714" cy="3164072"/>
                      <a:chOff x="462425" y="748161"/>
                      <a:chExt cx="6488714" cy="3164072"/>
                    </a:xfrm>
                  </p:grpSpPr>
                  <p:pic>
                    <p:nvPicPr>
                      <p:cNvPr id="3" name="Afbeelding 2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"/>
                      <a:srcRect t="30768" b="7693"/>
                      <a:stretch/>
                    </p:blipFill>
                    <p:spPr>
                      <a:xfrm>
                        <a:off x="462426" y="3480185"/>
                        <a:ext cx="5250331" cy="43204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4" name="Afbeelding 3"/>
                      <p:cNvPicPr>
                        <a:picLocks noChangeAspect="1"/>
                      </p:cNvPicPr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2427" y="2323337"/>
                        <a:ext cx="5250330" cy="41930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5" name="Afbeelding 4"/>
                      <p:cNvPicPr>
                        <a:picLocks noChangeAspect="1"/>
                      </p:cNvPicPr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6672" y="1835696"/>
                        <a:ext cx="5226032" cy="34692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  <p:pic>
                    <p:nvPicPr>
                      <p:cNvPr id="6" name="Afbeelding 5"/>
                      <p:cNvPicPr>
                        <a:picLocks noChangeAspect="1"/>
                      </p:cNvPicPr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6672" y="2861800"/>
                        <a:ext cx="5250331" cy="49922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  <p:sp>
                    <p:nvSpPr>
                      <p:cNvPr id="8" name="Tekstvak 7"/>
                      <p:cNvSpPr txBox="1"/>
                      <p:nvPr/>
                    </p:nvSpPr>
                    <p:spPr>
                      <a:xfrm>
                        <a:off x="462425" y="1475656"/>
                        <a:ext cx="6488714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nl-NL" sz="14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-        +        -       +      -      +       -        +       -      +        -        +</a:t>
                        </a:r>
                      </a:p>
                    </p:txBody>
                  </p:sp>
                  <p:sp>
                    <p:nvSpPr>
                      <p:cNvPr id="14" name="Tekstvak 13"/>
                      <p:cNvSpPr txBox="1"/>
                      <p:nvPr/>
                    </p:nvSpPr>
                    <p:spPr>
                      <a:xfrm>
                        <a:off x="2161534" y="1235935"/>
                        <a:ext cx="85879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nl-NL" sz="14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666N</a:t>
                        </a:r>
                      </a:p>
                    </p:txBody>
                  </p:sp>
                  <p:cxnSp>
                    <p:nvCxnSpPr>
                      <p:cNvPr id="19" name="Rechte verbindingslijn 18"/>
                      <p:cNvCxnSpPr/>
                      <p:nvPr/>
                    </p:nvCxnSpPr>
                    <p:spPr>
                      <a:xfrm>
                        <a:off x="3284984" y="1126162"/>
                        <a:ext cx="2417720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2" name="Tekstvak 21"/>
                      <p:cNvSpPr txBox="1"/>
                      <p:nvPr/>
                    </p:nvSpPr>
                    <p:spPr>
                      <a:xfrm>
                        <a:off x="3780428" y="766122"/>
                        <a:ext cx="14487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nl-NL" sz="14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R 1Gy 16hr </a:t>
                        </a:r>
                      </a:p>
                    </p:txBody>
                  </p:sp>
                  <p:sp>
                    <p:nvSpPr>
                      <p:cNvPr id="23" name="Tekstvak 22"/>
                      <p:cNvSpPr txBox="1"/>
                      <p:nvPr/>
                    </p:nvSpPr>
                    <p:spPr>
                      <a:xfrm>
                        <a:off x="1379422" y="748161"/>
                        <a:ext cx="144877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nl-NL" sz="14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IR-</a:t>
                        </a:r>
                      </a:p>
                    </p:txBody>
                  </p:sp>
                </p:grpSp>
              </p:grpSp>
            </p:grpSp>
          </p:grpSp>
          <p:sp>
            <p:nvSpPr>
              <p:cNvPr id="27" name="Tekstvak 26"/>
              <p:cNvSpPr txBox="1"/>
              <p:nvPr/>
            </p:nvSpPr>
            <p:spPr>
              <a:xfrm>
                <a:off x="-20707" y="1880702"/>
                <a:ext cx="13620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-KAP </a:t>
                </a:r>
              </a:p>
            </p:txBody>
          </p:sp>
          <p:sp>
            <p:nvSpPr>
              <p:cNvPr id="28" name="Tekstvak 27"/>
              <p:cNvSpPr txBox="1"/>
              <p:nvPr/>
            </p:nvSpPr>
            <p:spPr>
              <a:xfrm>
                <a:off x="89919" y="2356450"/>
                <a:ext cx="13620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KAP </a:t>
                </a:r>
              </a:p>
            </p:txBody>
          </p:sp>
          <p:sp>
            <p:nvSpPr>
              <p:cNvPr id="32" name="Tekstvak 31"/>
              <p:cNvSpPr txBox="1"/>
              <p:nvPr/>
            </p:nvSpPr>
            <p:spPr>
              <a:xfrm>
                <a:off x="-20707" y="2918104"/>
                <a:ext cx="13620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-p53 </a:t>
                </a:r>
              </a:p>
            </p:txBody>
          </p:sp>
          <p:sp>
            <p:nvSpPr>
              <p:cNvPr id="33" name="Tekstvak 32"/>
              <p:cNvSpPr txBox="1"/>
              <p:nvPr/>
            </p:nvSpPr>
            <p:spPr>
              <a:xfrm>
                <a:off x="17802" y="3536489"/>
                <a:ext cx="13620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53 </a:t>
                </a:r>
              </a:p>
            </p:txBody>
          </p:sp>
        </p:grpSp>
      </p:grpSp>
      <p:sp>
        <p:nvSpPr>
          <p:cNvPr id="26" name="Tekstvak 25"/>
          <p:cNvSpPr txBox="1"/>
          <p:nvPr/>
        </p:nvSpPr>
        <p:spPr>
          <a:xfrm>
            <a:off x="29808" y="130258"/>
            <a:ext cx="6768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NL" sz="1200" b="1" dirty="0">
                <a:latin typeface="Arial" panose="020B0604020202020204" pitchFamily="34" charset="0"/>
                <a:cs typeface="Arial" panose="020B0604020202020204" pitchFamily="34" charset="0"/>
              </a:rPr>
              <a:t> S5. 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Effect of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cyclin-dependent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kinase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inhibitio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on ATM/p53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response in NALM-6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-/+ </a:t>
            </a:r>
            <a:r>
              <a:rPr lang="nl-NL" sz="12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9277661"/>
              </p:ext>
            </p:extLst>
          </p:nvPr>
        </p:nvGraphicFramePr>
        <p:xfrm>
          <a:off x="127824" y="4415692"/>
          <a:ext cx="3716338" cy="2990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98" name="Prism 7" r:id="rId7" imgW="3896668" imgH="3137662" progId="Prism7.Document">
                  <p:embed/>
                </p:oleObj>
              </mc:Choice>
              <mc:Fallback>
                <p:oleObj name="Prism 7" r:id="rId7" imgW="3896668" imgH="3137662" progId="Prism7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7824" y="4415692"/>
                        <a:ext cx="3716338" cy="2990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/>
          <p:cNvSpPr txBox="1"/>
          <p:nvPr/>
        </p:nvSpPr>
        <p:spPr>
          <a:xfrm>
            <a:off x="57023" y="632828"/>
            <a:ext cx="269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7022" y="4415692"/>
            <a:ext cx="269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20276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0658428"/>
              </p:ext>
            </p:extLst>
          </p:nvPr>
        </p:nvGraphicFramePr>
        <p:xfrm>
          <a:off x="603739" y="485775"/>
          <a:ext cx="5691553" cy="6758275"/>
        </p:xfrm>
        <a:graphic>
          <a:graphicData uri="http://schemas.openxmlformats.org/drawingml/2006/table">
            <a:tbl>
              <a:tblPr/>
              <a:tblGrid>
                <a:gridCol w="674250">
                  <a:extLst>
                    <a:ext uri="{9D8B030D-6E8A-4147-A177-3AD203B41FA5}">
                      <a16:colId xmlns:a16="http://schemas.microsoft.com/office/drawing/2014/main" val="3536561144"/>
                    </a:ext>
                  </a:extLst>
                </a:gridCol>
                <a:gridCol w="557126">
                  <a:extLst>
                    <a:ext uri="{9D8B030D-6E8A-4147-A177-3AD203B41FA5}">
                      <a16:colId xmlns:a16="http://schemas.microsoft.com/office/drawing/2014/main" val="1061882817"/>
                    </a:ext>
                  </a:extLst>
                </a:gridCol>
                <a:gridCol w="468492">
                  <a:extLst>
                    <a:ext uri="{9D8B030D-6E8A-4147-A177-3AD203B41FA5}">
                      <a16:colId xmlns:a16="http://schemas.microsoft.com/office/drawing/2014/main" val="3060357557"/>
                    </a:ext>
                  </a:extLst>
                </a:gridCol>
                <a:gridCol w="1126915">
                  <a:extLst>
                    <a:ext uri="{9D8B030D-6E8A-4147-A177-3AD203B41FA5}">
                      <a16:colId xmlns:a16="http://schemas.microsoft.com/office/drawing/2014/main" val="2269924645"/>
                    </a:ext>
                  </a:extLst>
                </a:gridCol>
                <a:gridCol w="598278">
                  <a:extLst>
                    <a:ext uri="{9D8B030D-6E8A-4147-A177-3AD203B41FA5}">
                      <a16:colId xmlns:a16="http://schemas.microsoft.com/office/drawing/2014/main" val="908565508"/>
                    </a:ext>
                  </a:extLst>
                </a:gridCol>
                <a:gridCol w="861013">
                  <a:extLst>
                    <a:ext uri="{9D8B030D-6E8A-4147-A177-3AD203B41FA5}">
                      <a16:colId xmlns:a16="http://schemas.microsoft.com/office/drawing/2014/main" val="1032703549"/>
                    </a:ext>
                  </a:extLst>
                </a:gridCol>
                <a:gridCol w="911662">
                  <a:extLst>
                    <a:ext uri="{9D8B030D-6E8A-4147-A177-3AD203B41FA5}">
                      <a16:colId xmlns:a16="http://schemas.microsoft.com/office/drawing/2014/main" val="1938788629"/>
                    </a:ext>
                  </a:extLst>
                </a:gridCol>
                <a:gridCol w="493817">
                  <a:extLst>
                    <a:ext uri="{9D8B030D-6E8A-4147-A177-3AD203B41FA5}">
                      <a16:colId xmlns:a16="http://schemas.microsoft.com/office/drawing/2014/main" val="2151920909"/>
                    </a:ext>
                  </a:extLst>
                </a:gridCol>
              </a:tblGrid>
              <a:tr h="4990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I/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n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HV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, 11q or tris12 (%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egory functional analysis*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 (%)**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ino acid change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apy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5061903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0309 (1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/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l13q (9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 (3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7982496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536 (2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/C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5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 (5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942450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596 (3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/B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32), tris12 (6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8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111G: I704S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744643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0679 (4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96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888519"/>
                  </a:ext>
                </a:extLst>
              </a:tr>
              <a:tr h="2037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416 (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/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s12 (8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10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942484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15 (6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51.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62D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7840095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15 (7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4.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8372803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87 (8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order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9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60.4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27639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60 (9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41.8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594950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1046 (10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43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6407352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62 (11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±3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9490956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047 (12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0355314"/>
                  </a:ext>
                </a:extLst>
              </a:tr>
              <a:tr h="274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708 (13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24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5961211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982 (14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19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1865037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54 (15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233730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227 (16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675014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647 (17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0420965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56 (18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5937392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60 (19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1575708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636 (20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138689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854 (21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?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4441651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532 (22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900457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534 (23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7651857"/>
                  </a:ext>
                </a:extLst>
              </a:tr>
              <a:tr h="1190478"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2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ient characteristics and type of 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utations (VAF≥20%) from patients used for functional experiments. Rai-stage and/or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ne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age were determined at time of performance of functional analyses. FISH, mutational and functional analyses were performed at same time point in most patients, but at least within one year.*This column shows in which group patients were included for functional experiments.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% of mutant allele burden is mentioned. Abbreviation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UM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mutated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=mutated, NA=unknown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orambuci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8792" marR="8792" marT="8792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30340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096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5810509"/>
              </p:ext>
            </p:extLst>
          </p:nvPr>
        </p:nvGraphicFramePr>
        <p:xfrm>
          <a:off x="603739" y="485775"/>
          <a:ext cx="5691553" cy="7520799"/>
        </p:xfrm>
        <a:graphic>
          <a:graphicData uri="http://schemas.openxmlformats.org/drawingml/2006/table">
            <a:tbl>
              <a:tblPr/>
              <a:tblGrid>
                <a:gridCol w="674250">
                  <a:extLst>
                    <a:ext uri="{9D8B030D-6E8A-4147-A177-3AD203B41FA5}">
                      <a16:colId xmlns:a16="http://schemas.microsoft.com/office/drawing/2014/main" val="3536561144"/>
                    </a:ext>
                  </a:extLst>
                </a:gridCol>
                <a:gridCol w="557126">
                  <a:extLst>
                    <a:ext uri="{9D8B030D-6E8A-4147-A177-3AD203B41FA5}">
                      <a16:colId xmlns:a16="http://schemas.microsoft.com/office/drawing/2014/main" val="1061882817"/>
                    </a:ext>
                  </a:extLst>
                </a:gridCol>
                <a:gridCol w="468492">
                  <a:extLst>
                    <a:ext uri="{9D8B030D-6E8A-4147-A177-3AD203B41FA5}">
                      <a16:colId xmlns:a16="http://schemas.microsoft.com/office/drawing/2014/main" val="3060357557"/>
                    </a:ext>
                  </a:extLst>
                </a:gridCol>
                <a:gridCol w="1126915">
                  <a:extLst>
                    <a:ext uri="{9D8B030D-6E8A-4147-A177-3AD203B41FA5}">
                      <a16:colId xmlns:a16="http://schemas.microsoft.com/office/drawing/2014/main" val="2269924645"/>
                    </a:ext>
                  </a:extLst>
                </a:gridCol>
                <a:gridCol w="598278">
                  <a:extLst>
                    <a:ext uri="{9D8B030D-6E8A-4147-A177-3AD203B41FA5}">
                      <a16:colId xmlns:a16="http://schemas.microsoft.com/office/drawing/2014/main" val="908565508"/>
                    </a:ext>
                  </a:extLst>
                </a:gridCol>
                <a:gridCol w="861013">
                  <a:extLst>
                    <a:ext uri="{9D8B030D-6E8A-4147-A177-3AD203B41FA5}">
                      <a16:colId xmlns:a16="http://schemas.microsoft.com/office/drawing/2014/main" val="1032703549"/>
                    </a:ext>
                  </a:extLst>
                </a:gridCol>
                <a:gridCol w="911662">
                  <a:extLst>
                    <a:ext uri="{9D8B030D-6E8A-4147-A177-3AD203B41FA5}">
                      <a16:colId xmlns:a16="http://schemas.microsoft.com/office/drawing/2014/main" val="1938788629"/>
                    </a:ext>
                  </a:extLst>
                </a:gridCol>
                <a:gridCol w="493817">
                  <a:extLst>
                    <a:ext uri="{9D8B030D-6E8A-4147-A177-3AD203B41FA5}">
                      <a16:colId xmlns:a16="http://schemas.microsoft.com/office/drawing/2014/main" val="2151920909"/>
                    </a:ext>
                  </a:extLst>
                </a:gridCol>
              </a:tblGrid>
              <a:tr h="4990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I/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net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HV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, 11q or tris12 (%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egory functional analysis*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 (%)**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ino acid change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apy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5061903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0309 (1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/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l13q (9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 (3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7982496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536 (2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/C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5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 (5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942450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596 (3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/B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32), tris12 (6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8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111G: I704S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744643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0679 (4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96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0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888519"/>
                  </a:ext>
                </a:extLst>
              </a:tr>
              <a:tr h="2037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1416 (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/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s12 (8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100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942484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/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 (1%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673-1_688del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683199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15 (6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51.5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62D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7840095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15 (7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4.5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8372803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87 (8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order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90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60.4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27639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60 (9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41.8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E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594950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1046 (10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43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 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6407352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62 (11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±35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9490956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047 (12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0355314"/>
                  </a:ext>
                </a:extLst>
              </a:tr>
              <a:tr h="2749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708 (13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24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11.5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5961211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0982 (14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q (19)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1865037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54 (15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6233730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227 (16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675014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647 (17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0420965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56 (18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5937392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160 (19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1575708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636 (20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138689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854 (21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4441651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532 (22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900457"/>
                  </a:ext>
                </a:extLst>
              </a:tr>
              <a:tr h="2138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534 (23)</a:t>
                      </a:r>
                    </a:p>
                  </a:txBody>
                  <a:tcPr marL="8792" marR="8792" marT="8792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8792" marR="8792" marT="879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7651857"/>
                  </a:ext>
                </a:extLst>
              </a:tr>
              <a:tr h="1190478"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3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CLL patient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acteristics and type of mutations from patients used for functional experiments. Rai and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ne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age were determined at time of performance of functional analyses. FISH, mutational and functional analyses were performed at same time point in most patients, but at least within one year. *This column shows in which group patients were included for functional experiments,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%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f mutant allele burden is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ntioned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breviations: UM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mutated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=mutated, NA=unknown, fs=frame shift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orambuci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FCR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d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yclophosphamide and rituximab, Al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emtuzuma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R-CHOP=rituximab, cyclophosphamide, doxorubicin, vincristine and prednisone, R-CVP= rituximab, cyclophosphamide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ncristi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nd prednisone, R-DHAP= rituximab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xamethaso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nd cisplatin</a:t>
                      </a:r>
                    </a:p>
                  </a:txBody>
                  <a:tcPr marL="8792" marR="8792" marT="8792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30340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788571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0182390"/>
              </p:ext>
            </p:extLst>
          </p:nvPr>
        </p:nvGraphicFramePr>
        <p:xfrm>
          <a:off x="410308" y="79126"/>
          <a:ext cx="6002215" cy="8831845"/>
        </p:xfrm>
        <a:graphic>
          <a:graphicData uri="http://schemas.openxmlformats.org/drawingml/2006/table">
            <a:tbl>
              <a:tblPr/>
              <a:tblGrid>
                <a:gridCol w="546074">
                  <a:extLst>
                    <a:ext uri="{9D8B030D-6E8A-4147-A177-3AD203B41FA5}">
                      <a16:colId xmlns:a16="http://schemas.microsoft.com/office/drawing/2014/main" val="1392019251"/>
                    </a:ext>
                  </a:extLst>
                </a:gridCol>
                <a:gridCol w="640227">
                  <a:extLst>
                    <a:ext uri="{9D8B030D-6E8A-4147-A177-3AD203B41FA5}">
                      <a16:colId xmlns:a16="http://schemas.microsoft.com/office/drawing/2014/main" val="747910333"/>
                    </a:ext>
                  </a:extLst>
                </a:gridCol>
                <a:gridCol w="451925">
                  <a:extLst>
                    <a:ext uri="{9D8B030D-6E8A-4147-A177-3AD203B41FA5}">
                      <a16:colId xmlns:a16="http://schemas.microsoft.com/office/drawing/2014/main" val="1836864345"/>
                    </a:ext>
                  </a:extLst>
                </a:gridCol>
                <a:gridCol w="696717">
                  <a:extLst>
                    <a:ext uri="{9D8B030D-6E8A-4147-A177-3AD203B41FA5}">
                      <a16:colId xmlns:a16="http://schemas.microsoft.com/office/drawing/2014/main" val="163513098"/>
                    </a:ext>
                  </a:extLst>
                </a:gridCol>
                <a:gridCol w="790868">
                  <a:extLst>
                    <a:ext uri="{9D8B030D-6E8A-4147-A177-3AD203B41FA5}">
                      <a16:colId xmlns:a16="http://schemas.microsoft.com/office/drawing/2014/main" val="2047359372"/>
                    </a:ext>
                  </a:extLst>
                </a:gridCol>
                <a:gridCol w="527246">
                  <a:extLst>
                    <a:ext uri="{9D8B030D-6E8A-4147-A177-3AD203B41FA5}">
                      <a16:colId xmlns:a16="http://schemas.microsoft.com/office/drawing/2014/main" val="2181027385"/>
                    </a:ext>
                  </a:extLst>
                </a:gridCol>
                <a:gridCol w="954112">
                  <a:extLst>
                    <a:ext uri="{9D8B030D-6E8A-4147-A177-3AD203B41FA5}">
                      <a16:colId xmlns:a16="http://schemas.microsoft.com/office/drawing/2014/main" val="2779519606"/>
                    </a:ext>
                  </a:extLst>
                </a:gridCol>
                <a:gridCol w="1395046">
                  <a:extLst>
                    <a:ext uri="{9D8B030D-6E8A-4147-A177-3AD203B41FA5}">
                      <a16:colId xmlns:a16="http://schemas.microsoft.com/office/drawing/2014/main" val="2699015487"/>
                    </a:ext>
                  </a:extLst>
                </a:gridCol>
              </a:tblGrid>
              <a:tr h="38556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I/Binet 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GH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, 11q or tris12 (%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egory; functional analyses*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 (%)**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ino acid change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apy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1392175"/>
                  </a:ext>
                </a:extLst>
              </a:tr>
              <a:tr h="14653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9 (24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729STO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, R-CV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5470405"/>
                  </a:ext>
                </a:extLst>
              </a:tr>
              <a:tr h="14653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2423K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2191228"/>
                  </a:ext>
                </a:extLst>
              </a:tr>
              <a:tr h="14653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0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4843725"/>
                  </a:ext>
                </a:extLst>
              </a:tr>
              <a:tr h="146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2 (25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CH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2514fs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0291194"/>
                  </a:ext>
                </a:extLst>
              </a:tr>
              <a:tr h="146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75 (26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q (98) 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kipp.ex5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5394689"/>
                  </a:ext>
                </a:extLst>
              </a:tr>
              <a:tr h="1395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2 (27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 (53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273C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41262"/>
                  </a:ext>
                </a:extLst>
              </a:tr>
              <a:tr h="146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6 (28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 (67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135R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134531"/>
                  </a:ext>
                </a:extLst>
              </a:tr>
              <a:tr h="3150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5 (29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 (87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317STO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, CVP, FCR, Al, R-CHO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0072611"/>
                  </a:ext>
                </a:extLst>
              </a:tr>
              <a:tr h="2123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28 (3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p (94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178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, FCR, RDHA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4419782"/>
                  </a:ext>
                </a:extLst>
              </a:tr>
              <a:tr h="1395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4 (31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1492511"/>
                  </a:ext>
                </a:extLst>
              </a:tr>
              <a:tr h="2589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17 (32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(±30.0) 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073708"/>
                  </a:ext>
                </a:extLst>
              </a:tr>
              <a:tr h="1395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3 (33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q (8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2973W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, FCR, Al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5876284"/>
                  </a:ext>
                </a:extLst>
              </a:tr>
              <a:tr h="14653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 (34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q (NA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2624fs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5698649"/>
                  </a:ext>
                </a:extLst>
              </a:tr>
              <a:tr h="139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2953Q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4607621"/>
                  </a:ext>
                </a:extLst>
              </a:tr>
              <a:tr h="14653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55STO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9107552"/>
                  </a:ext>
                </a:extLst>
              </a:tr>
              <a:tr h="25895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0 (35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q (18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4.5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62D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9949191"/>
                  </a:ext>
                </a:extLst>
              </a:tr>
              <a:tr h="25895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CH1 (12.7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2515fs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1925617"/>
                  </a:ext>
                </a:extLst>
              </a:tr>
              <a:tr h="1323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8 (36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q (75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343fs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464315"/>
                  </a:ext>
                </a:extLst>
              </a:tr>
              <a:tr h="18141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4 (37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725237"/>
                  </a:ext>
                </a:extLst>
              </a:tr>
              <a:tr h="146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2 (38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9695562"/>
                  </a:ext>
                </a:extLst>
              </a:tr>
              <a:tr h="2589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0 (39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7.5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702918"/>
                  </a:ext>
                </a:extLst>
              </a:tr>
              <a:tr h="2589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2 (4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46.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713525"/>
                  </a:ext>
                </a:extLst>
              </a:tr>
              <a:tr h="2589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679 (41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647484"/>
                  </a:ext>
                </a:extLst>
              </a:tr>
              <a:tr h="3279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831 (42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 (40%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C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5114174"/>
                  </a:ext>
                </a:extLst>
              </a:tr>
              <a:tr h="1395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0 (43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844050"/>
                  </a:ext>
                </a:extLst>
              </a:tr>
              <a:tr h="1395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6 (44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6826712"/>
                  </a:ext>
                </a:extLst>
              </a:tr>
              <a:tr h="3070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7 (45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I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1501382"/>
                  </a:ext>
                </a:extLst>
              </a:tr>
              <a:tr h="1465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2 (46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259772"/>
                  </a:ext>
                </a:extLst>
              </a:tr>
              <a:tr h="139553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7 (47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|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40.2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8443596"/>
                  </a:ext>
                </a:extLst>
              </a:tr>
              <a:tr h="1323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6419085"/>
                  </a:ext>
                </a:extLst>
              </a:tr>
              <a:tr h="25895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4 (48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V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±45.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700E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FCR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208316"/>
                  </a:ext>
                </a:extLst>
              </a:tr>
              <a:tr h="2023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-CHOP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3615106"/>
                  </a:ext>
                </a:extLst>
              </a:tr>
              <a:tr h="2589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35 (49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q (11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&lt;5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704F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, R-CVP, FR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1911564"/>
                  </a:ext>
                </a:extLst>
              </a:tr>
              <a:tr h="2589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479 (5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M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50.0)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776D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CR</a:t>
                      </a:r>
                    </a:p>
                  </a:txBody>
                  <a:tcPr marL="5735" marR="5735" marT="573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092945"/>
                  </a:ext>
                </a:extLst>
              </a:tr>
              <a:tr h="1862670">
                <a:tc gridSpan="8">
                  <a:txBody>
                    <a:bodyPr/>
                    <a:lstStyle/>
                    <a:p>
                      <a:pPr algn="l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le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3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continued)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L patient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aracteristics and type of mutations from patients used for functional experiments. Rai and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ine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tage were determined at time of performance of functional analyses. FISH, mutational and functional analyses were performed at same time point in most patients, but at least within one year. *This column shows in which group patients were included for functional experiments,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%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f mutant allele burden is mentioned if available. Abbreviations: UM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mutated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M=mutated, NA=unknown, fs=frame shift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orambuci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FCR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ud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cyclophosphamide and rituximab, Al=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emtuzuma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R-CHOP=rituximab, cyclophosphamide, doxorubicin, vincristine and prednisone, R-CVP= rituximab, cyclophosphamide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incristi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nd prednisone, R-DHAP= rituximab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xamethaso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tarabin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and cisplat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5735" marR="5735" marT="573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03316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19372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321869" y="6444255"/>
            <a:ext cx="5551393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kumimoji="0" lang="en-US" alt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Patient </a:t>
            </a: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racteristics and type of mutations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om MDS patients used for functional experiments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This column shows in which group patients were included for functional experiment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**% of mutant allele burden is mentioned if available </a:t>
            </a:r>
            <a:endParaRPr kumimoji="0" lang="en-US" alt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125288"/>
              </p:ext>
            </p:extLst>
          </p:nvPr>
        </p:nvGraphicFramePr>
        <p:xfrm>
          <a:off x="418624" y="410306"/>
          <a:ext cx="4083038" cy="6034093"/>
        </p:xfrm>
        <a:graphic>
          <a:graphicData uri="http://schemas.openxmlformats.org/drawingml/2006/table">
            <a:tbl>
              <a:tblPr/>
              <a:tblGrid>
                <a:gridCol w="521151">
                  <a:extLst>
                    <a:ext uri="{9D8B030D-6E8A-4147-A177-3AD203B41FA5}">
                      <a16:colId xmlns:a16="http://schemas.microsoft.com/office/drawing/2014/main" val="1174455492"/>
                    </a:ext>
                  </a:extLst>
                </a:gridCol>
                <a:gridCol w="825156">
                  <a:extLst>
                    <a:ext uri="{9D8B030D-6E8A-4147-A177-3AD203B41FA5}">
                      <a16:colId xmlns:a16="http://schemas.microsoft.com/office/drawing/2014/main" val="3366000926"/>
                    </a:ext>
                  </a:extLst>
                </a:gridCol>
                <a:gridCol w="638300">
                  <a:extLst>
                    <a:ext uri="{9D8B030D-6E8A-4147-A177-3AD203B41FA5}">
                      <a16:colId xmlns:a16="http://schemas.microsoft.com/office/drawing/2014/main" val="1776854650"/>
                    </a:ext>
                  </a:extLst>
                </a:gridCol>
                <a:gridCol w="679938">
                  <a:extLst>
                    <a:ext uri="{9D8B030D-6E8A-4147-A177-3AD203B41FA5}">
                      <a16:colId xmlns:a16="http://schemas.microsoft.com/office/drawing/2014/main" val="2279167772"/>
                    </a:ext>
                  </a:extLst>
                </a:gridCol>
                <a:gridCol w="679939">
                  <a:extLst>
                    <a:ext uri="{9D8B030D-6E8A-4147-A177-3AD203B41FA5}">
                      <a16:colId xmlns:a16="http://schemas.microsoft.com/office/drawing/2014/main" val="260142658"/>
                    </a:ext>
                  </a:extLst>
                </a:gridCol>
                <a:gridCol w="738554">
                  <a:extLst>
                    <a:ext uri="{9D8B030D-6E8A-4147-A177-3AD203B41FA5}">
                      <a16:colId xmlns:a16="http://schemas.microsoft.com/office/drawing/2014/main" val="4091400449"/>
                    </a:ext>
                  </a:extLst>
                </a:gridCol>
              </a:tblGrid>
              <a:tr h="3995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hort 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egory; functional analyses*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%)**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ino acid change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cleotide change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488260"/>
                  </a:ext>
                </a:extLst>
              </a:tr>
              <a:tr h="2527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8479195"/>
                  </a:ext>
                </a:extLst>
              </a:tr>
              <a:tr h="26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NMT3A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788482"/>
                  </a:ext>
                </a:extLst>
              </a:tr>
              <a:tr h="26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6780761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848610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8027563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2196602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522206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T2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2087782"/>
                  </a:ext>
                </a:extLst>
              </a:tr>
              <a:tr h="236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2338061"/>
                  </a:ext>
                </a:extLst>
              </a:tr>
              <a:tr h="26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154" marR="8154" marT="8154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2849435"/>
                  </a:ext>
                </a:extLst>
              </a:tr>
              <a:tr h="26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2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333E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997A&gt;G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0708169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4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622D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866G&gt;C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7254021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9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622D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866G&gt;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7227822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8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625H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873C&gt;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4564204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0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62Q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86C&gt;G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4655666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6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62Q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86C&gt;G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0478691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5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662Q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86C&gt;G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813844"/>
                  </a:ext>
                </a:extLst>
              </a:tr>
              <a:tr h="3343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5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R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97A&gt;G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164532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6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R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97A&gt;G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3351605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31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666N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1998G&gt;T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6940500"/>
                  </a:ext>
                </a:extLst>
              </a:tr>
              <a:tr h="2690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OVON 89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3B1 (25)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742D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.2225G&gt;A</a:t>
                      </a:r>
                    </a:p>
                  </a:txBody>
                  <a:tcPr marL="8154" marR="8154" marT="815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1167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456375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0645040"/>
              </p:ext>
            </p:extLst>
          </p:nvPr>
        </p:nvGraphicFramePr>
        <p:xfrm>
          <a:off x="442468" y="592770"/>
          <a:ext cx="6070600" cy="5555683"/>
        </p:xfrm>
        <a:graphic>
          <a:graphicData uri="http://schemas.openxmlformats.org/drawingml/2006/table">
            <a:tbl>
              <a:tblPr/>
              <a:tblGrid>
                <a:gridCol w="443230">
                  <a:extLst>
                    <a:ext uri="{9D8B030D-6E8A-4147-A177-3AD203B41FA5}">
                      <a16:colId xmlns:a16="http://schemas.microsoft.com/office/drawing/2014/main" val="580030195"/>
                    </a:ext>
                  </a:extLst>
                </a:gridCol>
                <a:gridCol w="697865">
                  <a:extLst>
                    <a:ext uri="{9D8B030D-6E8A-4147-A177-3AD203B41FA5}">
                      <a16:colId xmlns:a16="http://schemas.microsoft.com/office/drawing/2014/main" val="416261919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464454543"/>
                    </a:ext>
                  </a:extLst>
                </a:gridCol>
                <a:gridCol w="1405255">
                  <a:extLst>
                    <a:ext uri="{9D8B030D-6E8A-4147-A177-3AD203B41FA5}">
                      <a16:colId xmlns:a16="http://schemas.microsoft.com/office/drawing/2014/main" val="625670670"/>
                    </a:ext>
                  </a:extLst>
                </a:gridCol>
                <a:gridCol w="608965">
                  <a:extLst>
                    <a:ext uri="{9D8B030D-6E8A-4147-A177-3AD203B41FA5}">
                      <a16:colId xmlns:a16="http://schemas.microsoft.com/office/drawing/2014/main" val="1119891055"/>
                    </a:ext>
                  </a:extLst>
                </a:gridCol>
                <a:gridCol w="583565">
                  <a:extLst>
                    <a:ext uri="{9D8B030D-6E8A-4147-A177-3AD203B41FA5}">
                      <a16:colId xmlns:a16="http://schemas.microsoft.com/office/drawing/2014/main" val="3260067533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298772285"/>
                    </a:ext>
                  </a:extLst>
                </a:gridCol>
                <a:gridCol w="468630">
                  <a:extLst>
                    <a:ext uri="{9D8B030D-6E8A-4147-A177-3AD203B41FA5}">
                      <a16:colId xmlns:a16="http://schemas.microsoft.com/office/drawing/2014/main" val="206924756"/>
                    </a:ext>
                  </a:extLst>
                </a:gridCol>
                <a:gridCol w="176530">
                  <a:extLst>
                    <a:ext uri="{9D8B030D-6E8A-4147-A177-3AD203B41FA5}">
                      <a16:colId xmlns:a16="http://schemas.microsoft.com/office/drawing/2014/main" val="1151252011"/>
                    </a:ext>
                  </a:extLst>
                </a:gridCol>
              </a:tblGrid>
              <a:tr h="426085"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 (diagnosis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NM classific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romosomal aberrations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egory;  Functional analysis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ut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mino acid chan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b="1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FS (m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1610569"/>
                  </a:ext>
                </a:extLst>
              </a:tr>
              <a:tr h="35750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8 (1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1p,+6p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IF1AX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9,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5092696"/>
                  </a:ext>
                </a:extLst>
              </a:tr>
              <a:tr h="374650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5 (2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IF1AX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5,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2515983"/>
                  </a:ext>
                </a:extLst>
              </a:tr>
              <a:tr h="36639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6 (3)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rma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IF1AX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5,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9345923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9 (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6p,-6q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Arg625Cy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9,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2729708"/>
                  </a:ext>
                </a:extLst>
              </a:tr>
              <a:tr h="179070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70 (5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6p,-6q, -8p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Arg625Hi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,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098477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74 (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6p,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Arg625Cy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5,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0109228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7 (7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p, +6p,-6q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F3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Arg625Cy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,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3672774"/>
                  </a:ext>
                </a:extLst>
              </a:tr>
              <a:tr h="179070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2 (8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,-8p,+8q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,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5001836"/>
                  </a:ext>
                </a:extLst>
              </a:tr>
              <a:tr h="179070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6 (9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,-8p,+8q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5,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7841708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4 (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,+6p,+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5,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7026370"/>
                  </a:ext>
                </a:extLst>
              </a:tr>
              <a:tr h="179070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0 (11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,-8p,+8q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,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5402645"/>
                  </a:ext>
                </a:extLst>
              </a:tr>
              <a:tr h="263525"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7 (12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3,-6q,-8p,+8q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800" kern="15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,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nl-NL" sz="1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2702127"/>
                  </a:ext>
                </a:extLst>
              </a:tr>
              <a:tr h="1345565">
                <a:tc gridSpan="9">
                  <a:txBody>
                    <a:bodyPr/>
                    <a:lstStyle/>
                    <a:p>
                      <a:pPr fontAlgn="t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ble S5</a:t>
                      </a:r>
                      <a:r>
                        <a:rPr lang="en-US" sz="1200" kern="1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. Patient characteristics and type of mutations from uveal melanoma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fontAlgn="t">
                        <a:lnSpc>
                          <a:spcPct val="106000"/>
                        </a:lnSpc>
                        <a:spcAft>
                          <a:spcPts val="0"/>
                        </a:spcAft>
                      </a:pPr>
                      <a:r>
                        <a:rPr lang="en-US" sz="1200" kern="15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UM) patients used for functional experiments. Age and TNM classification were determined at diagnosis. FISH, mutational and functional analyses were performed directly after enucleation. *This column shows in which group patients were included for functional experiments. MFS= metastasis free survival after enucleation in months (m).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17450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605232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23806" y="2536208"/>
          <a:ext cx="6584950" cy="3697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6" name="Prism 7" r:id="rId3" imgW="6261320" imgH="3515824" progId="Prism7.Document">
                  <p:embed/>
                </p:oleObj>
              </mc:Choice>
              <mc:Fallback>
                <p:oleObj name="Prism 7" r:id="rId3" imgW="6261320" imgH="3515824" progId="Prism7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806" y="2536208"/>
                        <a:ext cx="6584950" cy="3697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3806" y="12432"/>
            <a:ext cx="62011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NL" sz="1200" b="1" dirty="0">
                <a:latin typeface="Arial" panose="020B0604020202020204" pitchFamily="34" charset="0"/>
                <a:cs typeface="Arial" panose="020B0604020202020204" pitchFamily="34" charset="0"/>
              </a:rPr>
              <a:t>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alternatively spliced transcripts and DDR target RNAs and proteins in isogenic NALM-6 cells -/+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tation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23805" y="443020"/>
          <a:ext cx="3879818" cy="2466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7" name="Prism 7" r:id="rId5" imgW="5072151" imgH="3224819" progId="Prism7.Document">
                  <p:embed/>
                </p:oleObj>
              </mc:Choice>
              <mc:Fallback>
                <p:oleObj name="Prism 7" r:id="rId5" imgW="5072151" imgH="3224819" progId="Prism7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805" y="443020"/>
                        <a:ext cx="3879818" cy="2466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kstvak 22"/>
          <p:cNvSpPr txBox="1"/>
          <p:nvPr/>
        </p:nvSpPr>
        <p:spPr>
          <a:xfrm>
            <a:off x="14762" y="499790"/>
            <a:ext cx="4220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kstvak 22"/>
          <p:cNvSpPr txBox="1"/>
          <p:nvPr/>
        </p:nvSpPr>
        <p:spPr>
          <a:xfrm>
            <a:off x="23807" y="2711620"/>
            <a:ext cx="4220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321047" y="6002663"/>
            <a:ext cx="17883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+  IR 5Gy 16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Tx/>
              <a:buChar char="-"/>
            </a:pP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583" y="6002663"/>
            <a:ext cx="4004779" cy="3164269"/>
          </a:xfrm>
          <a:prstGeom prst="rect">
            <a:avLst/>
          </a:prstGeom>
        </p:spPr>
      </p:pic>
      <p:sp>
        <p:nvSpPr>
          <p:cNvPr id="22" name="Tekstvak 22"/>
          <p:cNvSpPr txBox="1"/>
          <p:nvPr/>
        </p:nvSpPr>
        <p:spPr>
          <a:xfrm>
            <a:off x="23807" y="5986306"/>
            <a:ext cx="4220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394622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kstvak 25"/>
          <p:cNvSpPr txBox="1"/>
          <p:nvPr/>
        </p:nvSpPr>
        <p:spPr>
          <a:xfrm>
            <a:off x="35980" y="644279"/>
            <a:ext cx="6768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NL" sz="1200" b="1" dirty="0">
                <a:latin typeface="Arial" panose="020B0604020202020204" pitchFamily="34" charset="0"/>
                <a:cs typeface="Arial" panose="020B0604020202020204" pitchFamily="34" charset="0"/>
              </a:rPr>
              <a:t>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DDR response in treatment naïv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tated CLL cells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isogenic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NALM-6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-/+ </a:t>
            </a:r>
            <a:r>
              <a:rPr lang="nl-NL" sz="12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15" name="Tekstvak 23"/>
          <p:cNvSpPr txBox="1"/>
          <p:nvPr/>
        </p:nvSpPr>
        <p:spPr>
          <a:xfrm>
            <a:off x="89919" y="1126373"/>
            <a:ext cx="533082" cy="3113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4080907"/>
              </p:ext>
            </p:extLst>
          </p:nvPr>
        </p:nvGraphicFramePr>
        <p:xfrm>
          <a:off x="150565" y="1085516"/>
          <a:ext cx="6538913" cy="369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03" name="Prism 7" r:id="rId3" imgW="6215582" imgH="3514383" progId="Prism7.Document">
                  <p:embed/>
                </p:oleObj>
              </mc:Choice>
              <mc:Fallback>
                <p:oleObj name="Prism 7" r:id="rId3" imgW="6215582" imgH="3514383" progId="Prism7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0565" y="1085516"/>
                        <a:ext cx="6538913" cy="3695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769094" y="4475251"/>
            <a:ext cx="17883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+  IR 1Gy 16 </a:t>
            </a:r>
            <a:r>
              <a:rPr lang="nl-NL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endParaRPr lang="nl-N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Tx/>
              <a:buChar char="-"/>
            </a:pP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001" y="7065598"/>
            <a:ext cx="1731047" cy="1848932"/>
          </a:xfrm>
          <a:prstGeom prst="rect">
            <a:avLst/>
          </a:prstGeom>
        </p:spPr>
      </p:pic>
      <p:sp>
        <p:nvSpPr>
          <p:cNvPr id="16" name="Tekstvak 23"/>
          <p:cNvSpPr txBox="1"/>
          <p:nvPr/>
        </p:nvSpPr>
        <p:spPr>
          <a:xfrm>
            <a:off x="150565" y="4657391"/>
            <a:ext cx="533082" cy="3113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65" y="4813090"/>
            <a:ext cx="3475829" cy="236241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2871" y="4839283"/>
            <a:ext cx="3376842" cy="2020856"/>
          </a:xfrm>
          <a:prstGeom prst="rect">
            <a:avLst/>
          </a:prstGeom>
        </p:spPr>
      </p:pic>
      <p:sp>
        <p:nvSpPr>
          <p:cNvPr id="11" name="Tekstvak 23"/>
          <p:cNvSpPr txBox="1"/>
          <p:nvPr/>
        </p:nvSpPr>
        <p:spPr>
          <a:xfrm>
            <a:off x="3499013" y="4658850"/>
            <a:ext cx="533082" cy="3113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kstvak 23"/>
          <p:cNvSpPr txBox="1"/>
          <p:nvPr/>
        </p:nvSpPr>
        <p:spPr>
          <a:xfrm>
            <a:off x="150565" y="7139368"/>
            <a:ext cx="533082" cy="3113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7152857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23807" y="12432"/>
            <a:ext cx="66537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NL" sz="1200" b="1" dirty="0">
                <a:latin typeface="Arial" panose="020B0604020202020204" pitchFamily="34" charset="0"/>
                <a:cs typeface="Arial" panose="020B0604020202020204" pitchFamily="34" charset="0"/>
              </a:rPr>
              <a:t> S3. 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Serine 139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phorylatio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of H2AX in response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IR in NALM-6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-/+ </a:t>
            </a:r>
            <a:r>
              <a:rPr lang="nl-NL" sz="1200" i="1" dirty="0">
                <a:latin typeface="Arial" panose="020B0604020202020204" pitchFamily="34" charset="0"/>
                <a:cs typeface="Arial" panose="020B0604020202020204" pitchFamily="34" charset="0"/>
              </a:rPr>
              <a:t>SF3B1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kstvak 25"/>
          <p:cNvSpPr txBox="1"/>
          <p:nvPr/>
        </p:nvSpPr>
        <p:spPr>
          <a:xfrm>
            <a:off x="89919" y="3612335"/>
            <a:ext cx="6768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NL" sz="1200" b="1" dirty="0">
                <a:latin typeface="Arial" panose="020B0604020202020204" pitchFamily="34" charset="0"/>
                <a:cs typeface="Arial" panose="020B0604020202020204" pitchFamily="34" charset="0"/>
              </a:rPr>
              <a:t> S4. 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Effect </a:t>
            </a:r>
            <a:r>
              <a:rPr lang="nl-NL" sz="1200" i="1" dirty="0">
                <a:latin typeface="Arial" panose="020B0604020202020204" pitchFamily="34" charset="0"/>
                <a:cs typeface="Arial" panose="020B0604020202020204" pitchFamily="34" charset="0"/>
              </a:rPr>
              <a:t>SF3B1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status on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resistance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fludarabine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) or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doxorubine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(right) in NALM-6 </a:t>
            </a:r>
            <a:r>
              <a:rPr lang="nl-NL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nl-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7899249"/>
              </p:ext>
            </p:extLst>
          </p:nvPr>
        </p:nvGraphicFramePr>
        <p:xfrm>
          <a:off x="2968625" y="4100513"/>
          <a:ext cx="2833688" cy="2859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121" name="Prism 8" r:id="rId3" imgW="2518429" imgH="2543048" progId="Prism8.Document">
                  <p:embed/>
                </p:oleObj>
              </mc:Choice>
              <mc:Fallback>
                <p:oleObj name="Prism 8" r:id="rId3" imgW="2518429" imgH="2543048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68625" y="4100513"/>
                        <a:ext cx="2833688" cy="2859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8144118"/>
              </p:ext>
            </p:extLst>
          </p:nvPr>
        </p:nvGraphicFramePr>
        <p:xfrm>
          <a:off x="184150" y="4110038"/>
          <a:ext cx="2822575" cy="284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122" name="Prism 8" r:id="rId5" imgW="2518429" imgH="2543048" progId="Prism8.Document">
                  <p:embed/>
                </p:oleObj>
              </mc:Choice>
              <mc:Fallback>
                <p:oleObj name="Prism 8" r:id="rId5" imgW="2518429" imgH="2543048" progId="Prism8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4150" y="4110038"/>
                        <a:ext cx="2822575" cy="284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0795963"/>
              </p:ext>
            </p:extLst>
          </p:nvPr>
        </p:nvGraphicFramePr>
        <p:xfrm>
          <a:off x="206375" y="552450"/>
          <a:ext cx="2922588" cy="300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123" name="Prism 8" r:id="rId7" imgW="2922501" imgH="3003685" progId="Prism8.Document">
                  <p:embed/>
                </p:oleObj>
              </mc:Choice>
              <mc:Fallback>
                <p:oleObj name="Prism 8" r:id="rId7" imgW="2922501" imgH="3003685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6375" y="552450"/>
                        <a:ext cx="2922588" cy="300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6619307"/>
              </p:ext>
            </p:extLst>
          </p:nvPr>
        </p:nvGraphicFramePr>
        <p:xfrm>
          <a:off x="3014663" y="549275"/>
          <a:ext cx="3530600" cy="3201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124" name="Prism 8" r:id="rId9" imgW="3530771" imgH="3201769" progId="Prism8.Document">
                  <p:embed/>
                </p:oleObj>
              </mc:Choice>
              <mc:Fallback>
                <p:oleObj name="Prism 8" r:id="rId9" imgW="3530771" imgH="320176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014663" y="549275"/>
                        <a:ext cx="3530600" cy="3201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1029201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3</TotalTime>
  <Words>2222</Words>
  <Application>Microsoft Office PowerPoint</Application>
  <PresentationFormat>On-screen Show (4:3)</PresentationFormat>
  <Paragraphs>961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Times New Roman</vt:lpstr>
      <vt:lpstr>Kantoorthema</vt:lpstr>
      <vt:lpstr>Prism 7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A.C. Leeksma</dc:creator>
  <cp:lastModifiedBy>Leeksma, A.C.</cp:lastModifiedBy>
  <cp:revision>258</cp:revision>
  <dcterms:created xsi:type="dcterms:W3CDTF">2018-05-25T15:10:15Z</dcterms:created>
  <dcterms:modified xsi:type="dcterms:W3CDTF">2020-12-23T10:55:51Z</dcterms:modified>
</cp:coreProperties>
</file>